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162" autoAdjust="0"/>
    <p:restoredTop sz="94660"/>
  </p:normalViewPr>
  <p:slideViewPr>
    <p:cSldViewPr snapToGrid="0">
      <p:cViewPr varScale="1">
        <p:scale>
          <a:sx n="84" d="100"/>
          <a:sy n="84" d="100"/>
        </p:scale>
        <p:origin x="282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4956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1562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3248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7463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32663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79058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4871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72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9591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8139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3962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759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図 25">
            <a:extLst>
              <a:ext uri="{FF2B5EF4-FFF2-40B4-BE49-F238E27FC236}">
                <a16:creationId xmlns:a16="http://schemas.microsoft.com/office/drawing/2014/main" id="{496BDB6D-171C-4E64-B624-15FD69A4CF6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79506" y="6678574"/>
            <a:ext cx="2834433" cy="2059534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5D339870-E448-4933-8DDA-E77F287104C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9581" y="6678574"/>
            <a:ext cx="2834433" cy="2059534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C59DEB95-97F6-49B7-BA60-CBD01A75457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7740" y="2314844"/>
            <a:ext cx="2743858" cy="1993721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59C43923-6AEA-4496-83D5-B816C70CCAA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66715" y="2314844"/>
            <a:ext cx="2743858" cy="1993721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800C4C02-3402-463C-BC6D-CD7B061F3F3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4835" y="4526943"/>
            <a:ext cx="2827465" cy="2054471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D2D9C07C-CB0E-4287-8E5F-E70362CA934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44760" y="4526943"/>
            <a:ext cx="2827465" cy="2054471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8653BD45-FCF1-4943-89BC-B1C0B5B4729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27008" y="111583"/>
            <a:ext cx="2842797" cy="2065611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9063BC82-B6C3-44A2-A75C-ADED9E61896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46458" y="111583"/>
            <a:ext cx="2842797" cy="2065611"/>
          </a:xfrm>
          <a:prstGeom prst="rect">
            <a:avLst/>
          </a:prstGeom>
        </p:spPr>
      </p:pic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3520C718-45A1-408E-9534-F957D2CF8A23}"/>
              </a:ext>
            </a:extLst>
          </p:cNvPr>
          <p:cNvSpPr txBox="1"/>
          <p:nvPr/>
        </p:nvSpPr>
        <p:spPr>
          <a:xfrm>
            <a:off x="750314" y="6798611"/>
            <a:ext cx="269121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612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CS: 3 knots  (HR: 95%CI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4.3 (1.57: 0.83-2.96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percentile = 7.4 (ref.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0.9 (1.09: 0.59-1.97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BD9E2393-D9C8-4715-9DE1-E81407D0EE7F}"/>
              </a:ext>
            </a:extLst>
          </p:cNvPr>
          <p:cNvSpPr txBox="1"/>
          <p:nvPr/>
        </p:nvSpPr>
        <p:spPr>
          <a:xfrm rot="16200000">
            <a:off x="-342530" y="7486265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766FE9EB-3CF9-4CF8-9062-A376A91BC28C}"/>
              </a:ext>
            </a:extLst>
          </p:cNvPr>
          <p:cNvSpPr txBox="1"/>
          <p:nvPr/>
        </p:nvSpPr>
        <p:spPr>
          <a:xfrm>
            <a:off x="1992841" y="858001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38BA8436-836C-4D21-B3F5-C3C24A68E629}"/>
              </a:ext>
            </a:extLst>
          </p:cNvPr>
          <p:cNvSpPr txBox="1"/>
          <p:nvPr/>
        </p:nvSpPr>
        <p:spPr>
          <a:xfrm rot="16200000">
            <a:off x="2866690" y="7486265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66AB23DB-5436-433C-89A2-D83C101FC91C}"/>
              </a:ext>
            </a:extLst>
          </p:cNvPr>
          <p:cNvSpPr txBox="1"/>
          <p:nvPr/>
        </p:nvSpPr>
        <p:spPr>
          <a:xfrm>
            <a:off x="5202061" y="858001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BF14D9AE-802A-43F3-BFF8-89033B384272}"/>
              </a:ext>
            </a:extLst>
          </p:cNvPr>
          <p:cNvSpPr txBox="1"/>
          <p:nvPr/>
        </p:nvSpPr>
        <p:spPr>
          <a:xfrm>
            <a:off x="4117402" y="6770234"/>
            <a:ext cx="2603161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60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2.1 (4.01: 1.19-13.5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CS: 3 knots  (HR: 95%CI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4.3 (2.11: 1.12-4.00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percentile = 7.4 (ref.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0.9 (0.89: 0.46-1.67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D7886AF4-48CA-4E1C-8FE4-71F227D2478C}"/>
              </a:ext>
            </a:extLst>
          </p:cNvPr>
          <p:cNvSpPr txBox="1"/>
          <p:nvPr/>
        </p:nvSpPr>
        <p:spPr>
          <a:xfrm>
            <a:off x="1207185" y="4468132"/>
            <a:ext cx="2691217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11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CS: 3 knots  (HR: 95%CI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4.3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1.19: 0.70-2.03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percentile = 7.4 (ref.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0.9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1.12: 0.76-1.66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9BA79ECF-6EDE-44D7-A201-DD34A822700F}"/>
              </a:ext>
            </a:extLst>
          </p:cNvPr>
          <p:cNvSpPr txBox="1"/>
          <p:nvPr/>
        </p:nvSpPr>
        <p:spPr>
          <a:xfrm rot="16200000">
            <a:off x="-342530" y="5325995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1B9B1E9F-D5C7-445A-B1DB-4476543725B1}"/>
              </a:ext>
            </a:extLst>
          </p:cNvPr>
          <p:cNvSpPr txBox="1"/>
          <p:nvPr/>
        </p:nvSpPr>
        <p:spPr>
          <a:xfrm>
            <a:off x="1992841" y="645403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E5C3A783-D1A6-47AA-AF39-33A3836159AB}"/>
              </a:ext>
            </a:extLst>
          </p:cNvPr>
          <p:cNvSpPr txBox="1"/>
          <p:nvPr/>
        </p:nvSpPr>
        <p:spPr>
          <a:xfrm rot="16200000">
            <a:off x="2866690" y="5325995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31637EEF-9B2B-4DFE-8A76-A573BF204701}"/>
              </a:ext>
            </a:extLst>
          </p:cNvPr>
          <p:cNvSpPr txBox="1"/>
          <p:nvPr/>
        </p:nvSpPr>
        <p:spPr>
          <a:xfrm>
            <a:off x="5202061" y="645403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482A12FA-55A9-4C79-8286-5A491DA47CE7}"/>
              </a:ext>
            </a:extLst>
          </p:cNvPr>
          <p:cNvSpPr txBox="1"/>
          <p:nvPr/>
        </p:nvSpPr>
        <p:spPr>
          <a:xfrm>
            <a:off x="4127204" y="4519920"/>
            <a:ext cx="260316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102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CS: 3 knots  (HR: 95%CI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4.3 (1.28: 0.76-2.17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percentile = 7.4 (ref.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0.9 (1.03: 0.68-1.55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295FDA79-F812-468B-A3DE-86BBCEC5347C}"/>
              </a:ext>
            </a:extLst>
          </p:cNvPr>
          <p:cNvSpPr txBox="1"/>
          <p:nvPr/>
        </p:nvSpPr>
        <p:spPr>
          <a:xfrm>
            <a:off x="681619" y="2383672"/>
            <a:ext cx="269121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092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CS: 3 knots (HR: 95%CI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3.3 (1.07: 0.68-1.68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percentile = 5.7 (ref.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8.7 (0.93: 0.59-1.48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46C93735-4F6D-4F97-9131-70C008CEB21D}"/>
              </a:ext>
            </a:extLst>
          </p:cNvPr>
          <p:cNvSpPr txBox="1"/>
          <p:nvPr/>
        </p:nvSpPr>
        <p:spPr>
          <a:xfrm rot="16200000">
            <a:off x="-342530" y="3074285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0BB619CD-5546-41D4-A8B6-D2A17016F037}"/>
              </a:ext>
            </a:extLst>
          </p:cNvPr>
          <p:cNvSpPr txBox="1"/>
          <p:nvPr/>
        </p:nvSpPr>
        <p:spPr>
          <a:xfrm>
            <a:off x="1992841" y="420232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C8E86210-65DC-4F48-AFB6-FEE5E5726405}"/>
              </a:ext>
            </a:extLst>
          </p:cNvPr>
          <p:cNvSpPr txBox="1"/>
          <p:nvPr/>
        </p:nvSpPr>
        <p:spPr>
          <a:xfrm rot="16200000">
            <a:off x="2866690" y="3074285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20ADD537-801D-4BB7-945A-40942AD5A1F9}"/>
              </a:ext>
            </a:extLst>
          </p:cNvPr>
          <p:cNvSpPr txBox="1"/>
          <p:nvPr/>
        </p:nvSpPr>
        <p:spPr>
          <a:xfrm>
            <a:off x="5202061" y="420232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047D4421-5C6A-4E0F-9953-761C206FBDB0}"/>
              </a:ext>
            </a:extLst>
          </p:cNvPr>
          <p:cNvSpPr txBox="1"/>
          <p:nvPr/>
        </p:nvSpPr>
        <p:spPr>
          <a:xfrm>
            <a:off x="3990034" y="2404325"/>
            <a:ext cx="269121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092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CS: 3 knots (HR: 95%CI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3.3 (1.12: 0.71-1.76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percentile = 5.7 (ref.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8.7 (0.86: 0.54-1.38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B2A086F9-CE4B-4D17-A65F-591032ADA1D4}"/>
              </a:ext>
            </a:extLst>
          </p:cNvPr>
          <p:cNvSpPr txBox="1"/>
          <p:nvPr/>
        </p:nvSpPr>
        <p:spPr>
          <a:xfrm>
            <a:off x="609132" y="239711"/>
            <a:ext cx="269121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904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3.3 (0.80: 0.60-1.06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percentile = 5.7 (ref.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8.7 (1.33: 0.93-1.89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51090A49-4C49-4BD4-B9C4-FA3C0EE01AFC}"/>
              </a:ext>
            </a:extLst>
          </p:cNvPr>
          <p:cNvSpPr txBox="1"/>
          <p:nvPr/>
        </p:nvSpPr>
        <p:spPr>
          <a:xfrm rot="16200000">
            <a:off x="-342530" y="925445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81C697B5-5A63-4D5C-96DC-51DCDF575F96}"/>
              </a:ext>
            </a:extLst>
          </p:cNvPr>
          <p:cNvSpPr txBox="1"/>
          <p:nvPr/>
        </p:nvSpPr>
        <p:spPr>
          <a:xfrm>
            <a:off x="1992841" y="205348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105E473A-B845-4690-AA02-F5971D3EA690}"/>
              </a:ext>
            </a:extLst>
          </p:cNvPr>
          <p:cNvSpPr txBox="1"/>
          <p:nvPr/>
        </p:nvSpPr>
        <p:spPr>
          <a:xfrm rot="16200000">
            <a:off x="2866690" y="925445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75CA1EC7-44C7-4FF6-9DC1-9968E19BF9E7}"/>
              </a:ext>
            </a:extLst>
          </p:cNvPr>
          <p:cNvSpPr txBox="1"/>
          <p:nvPr/>
        </p:nvSpPr>
        <p:spPr>
          <a:xfrm>
            <a:off x="5202061" y="205348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0C81CFAB-DB6B-4A21-B01C-C6C7412ADFC3}"/>
              </a:ext>
            </a:extLst>
          </p:cNvPr>
          <p:cNvSpPr txBox="1"/>
          <p:nvPr/>
        </p:nvSpPr>
        <p:spPr>
          <a:xfrm>
            <a:off x="3841348" y="272238"/>
            <a:ext cx="275733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906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3.3 (0.83: 0.62-1.11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percentile = 5.7 (ref.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8.7 (1.27: 0.88-1.83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704850" y="5114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3993868" y="5678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0" y="8723964"/>
            <a:ext cx="6858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5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Dose-response relationships of FMI with incident disability and mortality risks, excluding disabilities or deaths that occurred during the first two years of follow-up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F66FDD1-38C4-4C41-8CDD-B1C9287E5928}"/>
              </a:ext>
            </a:extLst>
          </p:cNvPr>
          <p:cNvSpPr txBox="1"/>
          <p:nvPr/>
        </p:nvSpPr>
        <p:spPr>
          <a:xfrm>
            <a:off x="0" y="0"/>
            <a:ext cx="1028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e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03D6331C-010B-4301-B5A4-50F6B8ED5345}"/>
              </a:ext>
            </a:extLst>
          </p:cNvPr>
          <p:cNvSpPr txBox="1"/>
          <p:nvPr/>
        </p:nvSpPr>
        <p:spPr>
          <a:xfrm>
            <a:off x="708660" y="220379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FAE4DD2A-D64A-4D19-89B3-77D9C2248B6D}"/>
              </a:ext>
            </a:extLst>
          </p:cNvPr>
          <p:cNvSpPr txBox="1"/>
          <p:nvPr/>
        </p:nvSpPr>
        <p:spPr>
          <a:xfrm>
            <a:off x="3997678" y="220943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C8155764-E544-4939-B205-5BD01424B661}"/>
              </a:ext>
            </a:extLst>
          </p:cNvPr>
          <p:cNvSpPr txBox="1"/>
          <p:nvPr/>
        </p:nvSpPr>
        <p:spPr>
          <a:xfrm>
            <a:off x="15240" y="4347210"/>
            <a:ext cx="1028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Wome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5C058EE1-9BBA-4DE6-8723-94ACDB0DCF75}"/>
              </a:ext>
            </a:extLst>
          </p:cNvPr>
          <p:cNvSpPr txBox="1"/>
          <p:nvPr/>
        </p:nvSpPr>
        <p:spPr>
          <a:xfrm>
            <a:off x="708660" y="429548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7BC9DF35-8B39-4895-B716-1EDFAA7FAD89}"/>
              </a:ext>
            </a:extLst>
          </p:cNvPr>
          <p:cNvSpPr txBox="1"/>
          <p:nvPr/>
        </p:nvSpPr>
        <p:spPr>
          <a:xfrm>
            <a:off x="3997678" y="430112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1EBABE77-10C9-41FE-93EC-DF11EB866820}"/>
              </a:ext>
            </a:extLst>
          </p:cNvPr>
          <p:cNvSpPr txBox="1"/>
          <p:nvPr/>
        </p:nvSpPr>
        <p:spPr>
          <a:xfrm>
            <a:off x="712470" y="659672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2DE9FB2B-8A6F-4D7D-BDDE-B109B99A8EB2}"/>
              </a:ext>
            </a:extLst>
          </p:cNvPr>
          <p:cNvSpPr txBox="1"/>
          <p:nvPr/>
        </p:nvSpPr>
        <p:spPr>
          <a:xfrm>
            <a:off x="4001488" y="660236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>
                <a:latin typeface="Arial" panose="020B0604020202020204" pitchFamily="34" charset="0"/>
                <a:cs typeface="Arial" panose="020B0604020202020204" pitchFamily="34" charset="0"/>
              </a:rPr>
              <a:t>h.</a:t>
            </a: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orta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55416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74</TotalTime>
  <Words>651</Words>
  <Application>Microsoft Office PowerPoint</Application>
  <PresentationFormat>画面に合わせる (4:3)</PresentationFormat>
  <Paragraphs>8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toshi Seino</dc:creator>
  <cp:lastModifiedBy>Seino Satoshi</cp:lastModifiedBy>
  <cp:revision>354</cp:revision>
  <cp:lastPrinted>2019-04-05T09:48:00Z</cp:lastPrinted>
  <dcterms:created xsi:type="dcterms:W3CDTF">2019-01-07T07:45:10Z</dcterms:created>
  <dcterms:modified xsi:type="dcterms:W3CDTF">2022-02-10T10:03:52Z</dcterms:modified>
</cp:coreProperties>
</file>